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  <p:sldId id="258" r:id="rId4"/>
    <p:sldId id="259" r:id="rId5"/>
    <p:sldId id="260" r:id="rId6"/>
    <p:sldId id="261" r:id="rId7"/>
    <p:sldId id="263" r:id="rId8"/>
    <p:sldId id="262" r:id="rId9"/>
    <p:sldId id="290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6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25" d="100"/>
          <a:sy n="125" d="100"/>
        </p:scale>
        <p:origin x="-1224" y="72"/>
      </p:cViewPr>
      <p:guideLst>
        <p:guide orient="horz" pos="663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7" Type="http://schemas.openxmlformats.org/officeDocument/2006/relationships/tableStyles" Target="tableStyles.xml"/><Relationship Id="rId36" Type="http://schemas.openxmlformats.org/officeDocument/2006/relationships/viewProps" Target="viewProps.xml"/><Relationship Id="rId35" Type="http://schemas.openxmlformats.org/officeDocument/2006/relationships/presProps" Target="presProps.xml"/><Relationship Id="rId34" Type="http://schemas.openxmlformats.org/officeDocument/2006/relationships/slide" Target="slides/slide32.xml"/><Relationship Id="rId33" Type="http://schemas.openxmlformats.org/officeDocument/2006/relationships/slide" Target="slides/slide31.xml"/><Relationship Id="rId32" Type="http://schemas.openxmlformats.org/officeDocument/2006/relationships/slide" Target="slides/slide30.xml"/><Relationship Id="rId31" Type="http://schemas.openxmlformats.org/officeDocument/2006/relationships/slide" Target="slides/slide29.xml"/><Relationship Id="rId30" Type="http://schemas.openxmlformats.org/officeDocument/2006/relationships/slide" Target="slides/slide28.xml"/><Relationship Id="rId3" Type="http://schemas.openxmlformats.org/officeDocument/2006/relationships/slide" Target="slides/slide1.xml"/><Relationship Id="rId29" Type="http://schemas.openxmlformats.org/officeDocument/2006/relationships/slide" Target="slides/slide27.xml"/><Relationship Id="rId28" Type="http://schemas.openxmlformats.org/officeDocument/2006/relationships/slide" Target="slides/slide26.xml"/><Relationship Id="rId27" Type="http://schemas.openxmlformats.org/officeDocument/2006/relationships/slide" Target="slides/slide25.xml"/><Relationship Id="rId26" Type="http://schemas.openxmlformats.org/officeDocument/2006/relationships/slide" Target="slides/slide24.xml"/><Relationship Id="rId25" Type="http://schemas.openxmlformats.org/officeDocument/2006/relationships/slide" Target="slides/slide23.xml"/><Relationship Id="rId24" Type="http://schemas.openxmlformats.org/officeDocument/2006/relationships/slide" Target="slides/slide22.xml"/><Relationship Id="rId23" Type="http://schemas.openxmlformats.org/officeDocument/2006/relationships/slide" Target="slides/slide21.xml"/><Relationship Id="rId22" Type="http://schemas.openxmlformats.org/officeDocument/2006/relationships/slide" Target="slides/slide20.xml"/><Relationship Id="rId21" Type="http://schemas.openxmlformats.org/officeDocument/2006/relationships/slide" Target="slides/slide19.xml"/><Relationship Id="rId20" Type="http://schemas.openxmlformats.org/officeDocument/2006/relationships/slide" Target="slides/slide18.xml"/><Relationship Id="rId2" Type="http://schemas.openxmlformats.org/officeDocument/2006/relationships/theme" Target="theme/theme1.xml"/><Relationship Id="rId19" Type="http://schemas.openxmlformats.org/officeDocument/2006/relationships/slide" Target="slides/slide17.xml"/><Relationship Id="rId18" Type="http://schemas.openxmlformats.org/officeDocument/2006/relationships/slide" Target="slides/slide16.xml"/><Relationship Id="rId17" Type="http://schemas.openxmlformats.org/officeDocument/2006/relationships/slide" Target="slides/slide15.xml"/><Relationship Id="rId16" Type="http://schemas.openxmlformats.org/officeDocument/2006/relationships/slide" Target="slides/slide14.xml"/><Relationship Id="rId15" Type="http://schemas.openxmlformats.org/officeDocument/2006/relationships/slide" Target="slides/slide13.xml"/><Relationship Id="rId14" Type="http://schemas.openxmlformats.org/officeDocument/2006/relationships/slide" Target="slides/slide12.xml"/><Relationship Id="rId13" Type="http://schemas.openxmlformats.org/officeDocument/2006/relationships/slide" Target="slides/slide11.xml"/><Relationship Id="rId12" Type="http://schemas.openxmlformats.org/officeDocument/2006/relationships/slide" Target="slides/slide10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1D3E5-D70A-4CF0-8533-E1CAECE0660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F997F-E30F-4949-8AA7-9ECD0066673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1D3E5-D70A-4CF0-8533-E1CAECE0660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F997F-E30F-4949-8AA7-9ECD0066673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1D3E5-D70A-4CF0-8533-E1CAECE0660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F997F-E30F-4949-8AA7-9ECD0066673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1D3E5-D70A-4CF0-8533-E1CAECE0660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F997F-E30F-4949-8AA7-9ECD0066673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1D3E5-D70A-4CF0-8533-E1CAECE0660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F997F-E30F-4949-8AA7-9ECD0066673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1D3E5-D70A-4CF0-8533-E1CAECE0660D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F997F-E30F-4949-8AA7-9ECD0066673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1D3E5-D70A-4CF0-8533-E1CAECE0660D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F997F-E30F-4949-8AA7-9ECD0066673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1D3E5-D70A-4CF0-8533-E1CAECE0660D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F997F-E30F-4949-8AA7-9ECD0066673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1D3E5-D70A-4CF0-8533-E1CAECE0660D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F997F-E30F-4949-8AA7-9ECD0066673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1D3E5-D70A-4CF0-8533-E1CAECE0660D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F997F-E30F-4949-8AA7-9ECD0066673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C1D3E5-D70A-4CF0-8533-E1CAECE0660D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DF997F-E30F-4949-8AA7-9ECD0066673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C1D3E5-D70A-4CF0-8533-E1CAECE0660D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DF997F-E30F-4949-8AA7-9ECD00666738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tiff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0.tiff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1.tiff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2.tiff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3.tiff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4.tiff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5.tiff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6.tiff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7.tiff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8.tiff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9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.tiff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0.tiff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1.tiff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2.tiff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3.tiff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4.tiff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5.tiff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6.tiff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7.tiff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8.tiff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9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3.tiff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30.tiff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31.tiff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32.tif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4.tif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5.tif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6.tif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7.tif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8.tiff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91608" y="1537610"/>
            <a:ext cx="101983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3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467906" y="1052736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295302" y="1027303"/>
            <a:ext cx="96393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5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接连接符 6"/>
          <p:cNvCxnSpPr/>
          <p:nvPr/>
        </p:nvCxnSpPr>
        <p:spPr>
          <a:xfrm>
            <a:off x="2339752" y="136051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1317675" y="1355776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9" name="图片 8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1448" y="1723644"/>
            <a:ext cx="4261104" cy="3410712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6266455" y="2715915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6369129" y="3112707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>
            <a:off x="6378598" y="3373984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6454898" y="2929144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460231" y="3175055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83568" y="532756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459023" y="507323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4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1555414" y="84053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533337" y="835796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矩形 11"/>
          <p:cNvSpPr/>
          <p:nvPr/>
        </p:nvSpPr>
        <p:spPr>
          <a:xfrm>
            <a:off x="244981" y="1124744"/>
            <a:ext cx="101983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9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1448" y="1723644"/>
            <a:ext cx="4261104" cy="341071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341138" y="2878107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6443812" y="3274899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>
            <a:off x="6453281" y="3536176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529581" y="3091336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534914" y="3337247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83568" y="532756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459023" y="507323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4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1555414" y="84053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533337" y="835796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矩形 9"/>
          <p:cNvSpPr/>
          <p:nvPr/>
        </p:nvSpPr>
        <p:spPr>
          <a:xfrm>
            <a:off x="272237" y="1139459"/>
            <a:ext cx="82266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γ-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1448" y="1723644"/>
            <a:ext cx="4261104" cy="341071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359806" y="2883416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6462480" y="3385007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548249" y="3201444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83568" y="532756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459023" y="507323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4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1555414" y="84053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533337" y="835796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矩形 9"/>
          <p:cNvSpPr/>
          <p:nvPr/>
        </p:nvSpPr>
        <p:spPr>
          <a:xfrm>
            <a:off x="422359" y="1268760"/>
            <a:ext cx="6714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P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4724" y="1965960"/>
            <a:ext cx="3654552" cy="292608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012160" y="2697279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6114834" y="3198870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6200603" y="3015307"/>
            <a:ext cx="4440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6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83568" y="532756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459023" y="507323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4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1555414" y="84053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533337" y="835796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403244" y="1302858"/>
            <a:ext cx="8418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clin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4724" y="1965960"/>
            <a:ext cx="3654552" cy="2926080"/>
          </a:xfrm>
          <a:prstGeom prst="rect">
            <a:avLst/>
          </a:prstGeom>
        </p:spPr>
      </p:pic>
      <p:cxnSp>
        <p:nvCxnSpPr>
          <p:cNvPr id="8" name="直接连接符 7"/>
          <p:cNvCxnSpPr/>
          <p:nvPr/>
        </p:nvCxnSpPr>
        <p:spPr>
          <a:xfrm>
            <a:off x="6106979" y="3121275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192748" y="2961967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038448" y="2641523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83568" y="532756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459023" y="507323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4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1555414" y="84053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533337" y="835796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454916" y="1351554"/>
            <a:ext cx="851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clinD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4724" y="1965960"/>
            <a:ext cx="3654552" cy="2926080"/>
          </a:xfrm>
          <a:prstGeom prst="rect">
            <a:avLst/>
          </a:prstGeom>
        </p:spPr>
      </p:pic>
      <p:cxnSp>
        <p:nvCxnSpPr>
          <p:cNvPr id="8" name="直接连接符 7"/>
          <p:cNvCxnSpPr/>
          <p:nvPr/>
        </p:nvCxnSpPr>
        <p:spPr>
          <a:xfrm>
            <a:off x="6084883" y="3112159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170652" y="2952851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6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016352" y="2632407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83568" y="532756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459023" y="507323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4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1555414" y="84053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533337" y="835796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683568" y="1364857"/>
            <a:ext cx="5229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C3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4724" y="1965960"/>
            <a:ext cx="3654552" cy="292608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5724128" y="2625864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接连接符 9"/>
          <p:cNvCxnSpPr/>
          <p:nvPr/>
        </p:nvCxnSpPr>
        <p:spPr>
          <a:xfrm>
            <a:off x="5826802" y="3022656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>
            <a:off x="5836271" y="3238213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5912571" y="2839093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917904" y="3039284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83568" y="532756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459023" y="507323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4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1555414" y="84053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533337" y="835796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395536" y="1541391"/>
            <a:ext cx="732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1448" y="1723644"/>
            <a:ext cx="4261104" cy="341071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012160" y="2636912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6114834" y="3138503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200603" y="2954940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821247" y="214073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610401" y="188640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6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接连接符 7"/>
          <p:cNvCxnSpPr/>
          <p:nvPr/>
        </p:nvCxnSpPr>
        <p:spPr>
          <a:xfrm>
            <a:off x="2693093" y="521850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1671016" y="51711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矩形 15"/>
          <p:cNvSpPr/>
          <p:nvPr/>
        </p:nvSpPr>
        <p:spPr>
          <a:xfrm>
            <a:off x="544949" y="698947"/>
            <a:ext cx="101983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3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1448" y="1723644"/>
            <a:ext cx="4261104" cy="3410712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6337328" y="2771403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6440002" y="3168195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>
            <a:off x="6449471" y="3429472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6525771" y="2984632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531104" y="3230543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21247" y="214073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610401" y="188640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6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2693093" y="521850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1671016" y="51711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矩形 11"/>
          <p:cNvSpPr/>
          <p:nvPr/>
        </p:nvSpPr>
        <p:spPr>
          <a:xfrm>
            <a:off x="542379" y="1142266"/>
            <a:ext cx="101983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9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1448" y="1723644"/>
            <a:ext cx="4261104" cy="341071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300192" y="2924944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6443812" y="3324047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>
            <a:off x="6453281" y="3585324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529581" y="3140484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534914" y="3386395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21247" y="214073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610401" y="188640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6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2693093" y="521850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1671016" y="51711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矩形 9"/>
          <p:cNvSpPr/>
          <p:nvPr/>
        </p:nvSpPr>
        <p:spPr>
          <a:xfrm>
            <a:off x="483830" y="849142"/>
            <a:ext cx="82266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γ-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1448" y="1723644"/>
            <a:ext cx="4261104" cy="341071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300192" y="2875203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6402866" y="3376794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488635" y="3193231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467906" y="1052736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295302" y="1027303"/>
            <a:ext cx="96393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5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2339752" y="136051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1317675" y="1355776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6" name="图片 5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1448" y="1723644"/>
            <a:ext cx="4261104" cy="3410712"/>
          </a:xfrm>
          <a:prstGeom prst="rect">
            <a:avLst/>
          </a:prstGeom>
        </p:spPr>
      </p:pic>
      <p:sp>
        <p:nvSpPr>
          <p:cNvPr id="7" name="矩形 6"/>
          <p:cNvSpPr/>
          <p:nvPr/>
        </p:nvSpPr>
        <p:spPr>
          <a:xfrm>
            <a:off x="189038" y="1950045"/>
            <a:ext cx="101983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9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6390286" y="2878107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6492960" y="3274899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>
            <a:off x="6502429" y="3536176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578729" y="3091336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584062" y="3337247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21247" y="214073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610401" y="188640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6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2693093" y="521850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1671016" y="51711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矩形 9"/>
          <p:cNvSpPr/>
          <p:nvPr/>
        </p:nvSpPr>
        <p:spPr>
          <a:xfrm>
            <a:off x="461541" y="836712"/>
            <a:ext cx="6714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P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4724" y="1965960"/>
            <a:ext cx="3654552" cy="292608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099701" y="2803788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6202375" y="3305379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6288144" y="3121816"/>
            <a:ext cx="4440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6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21247" y="214073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610401" y="188640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6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2693093" y="521850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1671016" y="51711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377277" y="887171"/>
            <a:ext cx="8418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clin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4724" y="1965960"/>
            <a:ext cx="3654552" cy="2926080"/>
          </a:xfrm>
          <a:prstGeom prst="rect">
            <a:avLst/>
          </a:prstGeom>
        </p:spPr>
      </p:pic>
      <p:cxnSp>
        <p:nvCxnSpPr>
          <p:cNvPr id="8" name="直接连接符 7"/>
          <p:cNvCxnSpPr/>
          <p:nvPr/>
        </p:nvCxnSpPr>
        <p:spPr>
          <a:xfrm>
            <a:off x="6194227" y="3011167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279996" y="285185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125696" y="2531415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21247" y="214073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610401" y="188640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6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2693093" y="521850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1671016" y="51711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382201" y="788321"/>
            <a:ext cx="851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clinD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4724" y="1965960"/>
            <a:ext cx="3654552" cy="2926080"/>
          </a:xfrm>
          <a:prstGeom prst="rect">
            <a:avLst/>
          </a:prstGeom>
        </p:spPr>
      </p:pic>
      <p:cxnSp>
        <p:nvCxnSpPr>
          <p:cNvPr id="8" name="直接连接符 7"/>
          <p:cNvCxnSpPr/>
          <p:nvPr/>
        </p:nvCxnSpPr>
        <p:spPr>
          <a:xfrm>
            <a:off x="6069814" y="3072127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155583" y="291281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6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001283" y="2592375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21247" y="214073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610401" y="188640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6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2693093" y="521850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1671016" y="51711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621933" y="968840"/>
            <a:ext cx="5229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C3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4724" y="1965960"/>
            <a:ext cx="3654552" cy="292608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5724128" y="2785120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接连接符 9"/>
          <p:cNvCxnSpPr/>
          <p:nvPr/>
        </p:nvCxnSpPr>
        <p:spPr>
          <a:xfrm>
            <a:off x="5826802" y="3181912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>
            <a:off x="5836271" y="3374609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5912571" y="299834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917904" y="3198540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21247" y="214073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610401" y="188640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6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2693093" y="521850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1671016" y="51711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430205" y="980728"/>
            <a:ext cx="732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1448" y="1723644"/>
            <a:ext cx="4261104" cy="341071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963571" y="2420888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6066245" y="2922479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152014" y="2738916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43608" y="496417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819063" y="470984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8,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1915454" y="804194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893377" y="799457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矩形 11"/>
          <p:cNvSpPr/>
          <p:nvPr/>
        </p:nvSpPr>
        <p:spPr>
          <a:xfrm>
            <a:off x="315684" y="988377"/>
            <a:ext cx="101983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3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1448" y="1723644"/>
            <a:ext cx="4261104" cy="341071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318278" y="2715915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6420952" y="3112707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>
            <a:off x="6430421" y="3373984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506721" y="2929144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512054" y="3175055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43608" y="496417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819063" y="470984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8,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直接连接符 7"/>
          <p:cNvCxnSpPr/>
          <p:nvPr/>
        </p:nvCxnSpPr>
        <p:spPr>
          <a:xfrm>
            <a:off x="1915454" y="804194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直接连接符 8"/>
          <p:cNvCxnSpPr/>
          <p:nvPr/>
        </p:nvCxnSpPr>
        <p:spPr>
          <a:xfrm>
            <a:off x="893377" y="799457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矩形 15"/>
          <p:cNvSpPr/>
          <p:nvPr/>
        </p:nvSpPr>
        <p:spPr>
          <a:xfrm>
            <a:off x="290415" y="1052736"/>
            <a:ext cx="101983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9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1448" y="1723644"/>
            <a:ext cx="4261104" cy="3410712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6390286" y="2826648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6492960" y="3223440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连接符 11"/>
          <p:cNvCxnSpPr/>
          <p:nvPr/>
        </p:nvCxnSpPr>
        <p:spPr>
          <a:xfrm>
            <a:off x="6502429" y="3484717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6578729" y="3039877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584062" y="3285788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43608" y="496417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819063" y="470984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8,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1915454" y="804194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893377" y="799457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矩形 9"/>
          <p:cNvSpPr/>
          <p:nvPr/>
        </p:nvSpPr>
        <p:spPr>
          <a:xfrm>
            <a:off x="373822" y="1198354"/>
            <a:ext cx="82266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γ-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1448" y="1723644"/>
            <a:ext cx="4261104" cy="341071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243424" y="2845316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6346098" y="3346907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431867" y="3163344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43608" y="496417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819063" y="470984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8,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1915454" y="804194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893377" y="799457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矩形 9"/>
          <p:cNvSpPr/>
          <p:nvPr/>
        </p:nvSpPr>
        <p:spPr>
          <a:xfrm>
            <a:off x="372142" y="1229084"/>
            <a:ext cx="6714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P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4724" y="1965960"/>
            <a:ext cx="3654552" cy="292608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080507" y="2818435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6183181" y="3320026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6268950" y="3136463"/>
            <a:ext cx="4440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6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43608" y="496417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819063" y="470984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8,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1915454" y="804194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893377" y="799457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377854" y="1249884"/>
            <a:ext cx="8418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clin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4724" y="1965960"/>
            <a:ext cx="3654552" cy="2926080"/>
          </a:xfrm>
          <a:prstGeom prst="rect">
            <a:avLst/>
          </a:prstGeom>
        </p:spPr>
      </p:pic>
      <p:cxnSp>
        <p:nvCxnSpPr>
          <p:cNvPr id="8" name="直接连接符 7"/>
          <p:cNvCxnSpPr/>
          <p:nvPr/>
        </p:nvCxnSpPr>
        <p:spPr>
          <a:xfrm>
            <a:off x="6217258" y="3234811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303027" y="3075503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148727" y="2755059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467906" y="1052736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295302" y="1027303"/>
            <a:ext cx="96393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5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2339752" y="136051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1317675" y="1355776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矩形 8"/>
          <p:cNvSpPr/>
          <p:nvPr/>
        </p:nvSpPr>
        <p:spPr>
          <a:xfrm>
            <a:off x="251520" y="1556792"/>
            <a:ext cx="82266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γ-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1448" y="1723644"/>
            <a:ext cx="4261104" cy="341071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420766" y="2708920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接连接符 9"/>
          <p:cNvCxnSpPr/>
          <p:nvPr/>
        </p:nvCxnSpPr>
        <p:spPr>
          <a:xfrm>
            <a:off x="6523440" y="3210511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6609209" y="3026948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43608" y="496417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819063" y="470984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8,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1915454" y="804194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893377" y="799457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354102" y="1289567"/>
            <a:ext cx="851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clinD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4724" y="1965960"/>
            <a:ext cx="3654552" cy="2926080"/>
          </a:xfrm>
          <a:prstGeom prst="rect">
            <a:avLst/>
          </a:prstGeom>
        </p:spPr>
      </p:pic>
      <p:cxnSp>
        <p:nvCxnSpPr>
          <p:cNvPr id="8" name="直接连接符 7"/>
          <p:cNvCxnSpPr/>
          <p:nvPr/>
        </p:nvCxnSpPr>
        <p:spPr>
          <a:xfrm>
            <a:off x="6111342" y="3128895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197111" y="2969587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6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042811" y="2649143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43608" y="496417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819063" y="470984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8,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1915454" y="804194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893377" y="799457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488838" y="1157332"/>
            <a:ext cx="5229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C3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4724" y="1965960"/>
            <a:ext cx="3654552" cy="292608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5742214" y="2779811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接连接符 9"/>
          <p:cNvCxnSpPr/>
          <p:nvPr/>
        </p:nvCxnSpPr>
        <p:spPr>
          <a:xfrm>
            <a:off x="5844888" y="3176603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连接符 10"/>
          <p:cNvCxnSpPr/>
          <p:nvPr/>
        </p:nvCxnSpPr>
        <p:spPr>
          <a:xfrm>
            <a:off x="5854357" y="3392160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5930657" y="2993040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935990" y="3193231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43608" y="496417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819063" y="470984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8,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1915454" y="804194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893377" y="799457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97111" y="1641643"/>
            <a:ext cx="732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1448" y="1723644"/>
            <a:ext cx="4261104" cy="341071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868144" y="2450775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5970818" y="2952366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6056587" y="2768803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467906" y="1052736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295302" y="1027303"/>
            <a:ext cx="96393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5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2339752" y="136051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1317675" y="1355776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矩形 8"/>
          <p:cNvSpPr/>
          <p:nvPr/>
        </p:nvSpPr>
        <p:spPr>
          <a:xfrm>
            <a:off x="460037" y="1484784"/>
            <a:ext cx="6714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P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4724" y="1965960"/>
            <a:ext cx="3654552" cy="292608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057647" y="2862808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6160321" y="3364399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6246090" y="3180836"/>
            <a:ext cx="44409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6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467906" y="1052736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295302" y="1027303"/>
            <a:ext cx="96393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5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2339752" y="136051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1317675" y="1355776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282996" y="1591175"/>
            <a:ext cx="84189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clin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4724" y="1965960"/>
            <a:ext cx="3654552" cy="2926080"/>
          </a:xfrm>
          <a:prstGeom prst="rect">
            <a:avLst/>
          </a:prstGeom>
        </p:spPr>
      </p:pic>
      <p:cxnSp>
        <p:nvCxnSpPr>
          <p:cNvPr id="10" name="直接连接符 9"/>
          <p:cNvCxnSpPr/>
          <p:nvPr/>
        </p:nvCxnSpPr>
        <p:spPr>
          <a:xfrm>
            <a:off x="6262978" y="3166995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348747" y="3007687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194447" y="2687243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467906" y="1052736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295302" y="1027303"/>
            <a:ext cx="96393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5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2339752" y="136051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1317675" y="1355776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271944" y="1591775"/>
            <a:ext cx="85151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clinD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4724" y="1965960"/>
            <a:ext cx="3654552" cy="2926080"/>
          </a:xfrm>
          <a:prstGeom prst="rect">
            <a:avLst/>
          </a:prstGeom>
        </p:spPr>
      </p:pic>
      <p:cxnSp>
        <p:nvCxnSpPr>
          <p:cNvPr id="9" name="直接连接符 8"/>
          <p:cNvCxnSpPr/>
          <p:nvPr/>
        </p:nvCxnSpPr>
        <p:spPr>
          <a:xfrm>
            <a:off x="6008683" y="3096919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094452" y="2937611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6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940152" y="2617167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467906" y="1052736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295302" y="1027303"/>
            <a:ext cx="96393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5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2339752" y="136051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1317675" y="1355776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467544" y="1628800"/>
            <a:ext cx="5229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C3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44724" y="1965960"/>
            <a:ext cx="3654552" cy="292608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724128" y="2708920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5826802" y="3105712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>
            <a:off x="5836271" y="3321269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5912571" y="292214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917904" y="3122340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5576" y="1772816"/>
            <a:ext cx="5760640" cy="4610984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467906" y="1052736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295302" y="1027303"/>
            <a:ext cx="96393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5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接连接符 6"/>
          <p:cNvCxnSpPr/>
          <p:nvPr/>
        </p:nvCxnSpPr>
        <p:spPr>
          <a:xfrm>
            <a:off x="2339752" y="136051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直接连接符 7"/>
          <p:cNvCxnSpPr/>
          <p:nvPr/>
        </p:nvCxnSpPr>
        <p:spPr>
          <a:xfrm>
            <a:off x="1317675" y="1355776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323528" y="1163451"/>
            <a:ext cx="7328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660107" y="3183573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5762781" y="3685164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5848550" y="3501601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83568" y="532756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459023" y="507323"/>
            <a:ext cx="106299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14, 30μM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连接符 3"/>
          <p:cNvCxnSpPr/>
          <p:nvPr/>
        </p:nvCxnSpPr>
        <p:spPr>
          <a:xfrm>
            <a:off x="1555414" y="840533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533337" y="835796"/>
            <a:ext cx="878061" cy="0"/>
          </a:xfrm>
          <a:prstGeom prst="line">
            <a:avLst/>
          </a:prstGeom>
          <a:ln w="2222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" name="矩形 11"/>
          <p:cNvSpPr/>
          <p:nvPr/>
        </p:nvSpPr>
        <p:spPr>
          <a:xfrm>
            <a:off x="247551" y="1129036"/>
            <a:ext cx="101983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spase3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1448" y="1723644"/>
            <a:ext cx="4261104" cy="341071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266455" y="2715915"/>
            <a:ext cx="5377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6369129" y="3131757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>
            <a:off x="6378598" y="3393034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6454898" y="2948194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460231" y="3194105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56</Words>
  <Application>WPS 演示</Application>
  <PresentationFormat>全屏显示(4:3)</PresentationFormat>
  <Paragraphs>344</Paragraphs>
  <Slides>3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2</vt:i4>
      </vt:variant>
    </vt:vector>
  </HeadingPairs>
  <TitlesOfParts>
    <vt:vector size="40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User</dc:creator>
  <cp:lastModifiedBy>且听风吟</cp:lastModifiedBy>
  <cp:revision>55</cp:revision>
  <dcterms:created xsi:type="dcterms:W3CDTF">2023-10-24T07:14:00Z</dcterms:created>
  <dcterms:modified xsi:type="dcterms:W3CDTF">2025-01-21T01:46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0FCC17702A147A2A81BE59FDAF74AC5_12</vt:lpwstr>
  </property>
  <property fmtid="{D5CDD505-2E9C-101B-9397-08002B2CF9AE}" pid="3" name="KSOProductBuildVer">
    <vt:lpwstr>2052-12.1.0.19770</vt:lpwstr>
  </property>
</Properties>
</file>